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jpeg" ContentType="image/jpe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B05A48-7614-4981-897B-C7F3F1D18BD8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1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Normal Voluntee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PYBF2_1hr_HIGASHI^TATSUYA.20131111_ZM3fpsColor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50yo, Ma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VR=1.08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スライド番号プレースホルダー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6DEF59E-DC10-4716-B9D5-C2944FBA7CA6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B178FE-A089-4BCA-9F33-4B164284D4B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EDCE73-B27F-445D-A5AA-3D2874D19E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ABC1AD-7BB1-42CC-84EB-8791B99FA39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B2567E-537F-4C08-BDF4-BD75CB982CF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C1CADD-E58B-4259-8A5A-69F9CC2DF5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89BFBE-9C27-4749-BC7B-AAC849EE6B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66FA00-4199-4894-B7C2-5D77B5F1FB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535F9A-6246-4244-B8D6-EE82FE66D3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2A7D07-0C01-4A11-975A-55BBF6F8FE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490BA9-AD85-4CDD-BDDA-9FBA8EE893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27E2D5-72F4-484E-BF73-AE2D0EB4A9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85BC4E-B8ED-4E57-BCD7-DEF2CCF0FA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FAF916-4711-4CA2-A792-5B45CC596672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67B991-8185-4F70-A199-A6FA81D4725E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jpe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図 10" descr=""/>
          <p:cNvPicPr/>
          <p:nvPr/>
        </p:nvPicPr>
        <p:blipFill>
          <a:blip r:embed="rId1"/>
          <a:stretch/>
        </p:blipFill>
        <p:spPr>
          <a:xfrm>
            <a:off x="1679400" y="1219320"/>
            <a:ext cx="6828120" cy="5216400"/>
          </a:xfrm>
          <a:prstGeom prst="rect">
            <a:avLst/>
          </a:prstGeom>
          <a:ln w="0">
            <a:noFill/>
          </a:ln>
        </p:spPr>
      </p:pic>
      <p:sp>
        <p:nvSpPr>
          <p:cNvPr id="49" name="タイトル 1"/>
          <p:cNvSpPr/>
          <p:nvPr/>
        </p:nvSpPr>
        <p:spPr>
          <a:xfrm>
            <a:off x="708120" y="476280"/>
            <a:ext cx="8229600" cy="77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ＭＳ Ｐゴシック"/>
              </a:rPr>
              <a:t>Mean Cortical Index of SUVR in Healthy Voluntee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正方形/長方形 3"/>
          <p:cNvSpPr/>
          <p:nvPr/>
        </p:nvSpPr>
        <p:spPr>
          <a:xfrm>
            <a:off x="790560" y="6165720"/>
            <a:ext cx="835344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正方形/長方形 4"/>
          <p:cNvSpPr/>
          <p:nvPr/>
        </p:nvSpPr>
        <p:spPr>
          <a:xfrm>
            <a:off x="2741760" y="6156360"/>
            <a:ext cx="7095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ＭＳ Ｐゴシック"/>
              </a:rPr>
              <a:t>20-39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ＭＳ Ｐゴシック"/>
              </a:rPr>
              <a:t>(n=8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正方形/長方形 5"/>
          <p:cNvSpPr/>
          <p:nvPr/>
        </p:nvSpPr>
        <p:spPr>
          <a:xfrm>
            <a:off x="3751560" y="6165720"/>
            <a:ext cx="7981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ＭＳ Ｐゴシック"/>
              </a:rPr>
              <a:t>40-49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ＭＳ Ｐゴシック"/>
              </a:rPr>
              <a:t>(n=18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正方形/長方形 6"/>
          <p:cNvSpPr/>
          <p:nvPr/>
        </p:nvSpPr>
        <p:spPr>
          <a:xfrm>
            <a:off x="4808160" y="6176880"/>
            <a:ext cx="7981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ＭＳ Ｐゴシック"/>
              </a:rPr>
              <a:t>50-59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ＭＳ Ｐゴシック"/>
              </a:rPr>
              <a:t>(n=16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正方形/長方形 7"/>
          <p:cNvSpPr/>
          <p:nvPr/>
        </p:nvSpPr>
        <p:spPr>
          <a:xfrm>
            <a:off x="5907240" y="6186600"/>
            <a:ext cx="7095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ＭＳ Ｐゴシック"/>
              </a:rPr>
              <a:t>60-69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ＭＳ Ｐゴシック"/>
              </a:rPr>
              <a:t>(n=7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正方形/長方形 8"/>
          <p:cNvSpPr/>
          <p:nvPr/>
        </p:nvSpPr>
        <p:spPr>
          <a:xfrm>
            <a:off x="6847920" y="6186600"/>
            <a:ext cx="79812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ＭＳ Ｐゴシック"/>
              </a:rPr>
              <a:t>70-79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ＭＳ Ｐゴシック"/>
              </a:rPr>
              <a:t>(n=12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テキスト ボックス 33"/>
          <p:cNvSpPr/>
          <p:nvPr/>
        </p:nvSpPr>
        <p:spPr>
          <a:xfrm>
            <a:off x="4653000" y="800280"/>
            <a:ext cx="1309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&lt;0.0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7" name="グループ化 38"/>
          <p:cNvGrpSpPr/>
          <p:nvPr/>
        </p:nvGrpSpPr>
        <p:grpSpPr>
          <a:xfrm>
            <a:off x="3108240" y="1119240"/>
            <a:ext cx="4114800" cy="187200"/>
            <a:chOff x="3108240" y="1119240"/>
            <a:chExt cx="4114800" cy="187200"/>
          </a:xfrm>
        </p:grpSpPr>
        <p:sp>
          <p:nvSpPr>
            <p:cNvPr id="58" name="直線コネクタ 11"/>
            <p:cNvSpPr/>
            <p:nvPr/>
          </p:nvSpPr>
          <p:spPr>
            <a:xfrm flipV="1">
              <a:off x="3108240" y="1119240"/>
              <a:ext cx="0" cy="1872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直線コネクタ 12"/>
            <p:cNvSpPr/>
            <p:nvPr/>
          </p:nvSpPr>
          <p:spPr>
            <a:xfrm flipV="1">
              <a:off x="7223040" y="1119240"/>
              <a:ext cx="0" cy="1872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直線コネクタ 13"/>
            <p:cNvSpPr/>
            <p:nvPr/>
          </p:nvSpPr>
          <p:spPr>
            <a:xfrm flipH="1">
              <a:off x="3108240" y="1119240"/>
              <a:ext cx="41148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1" name="テキスト ボックス 16"/>
          <p:cNvSpPr/>
          <p:nvPr/>
        </p:nvSpPr>
        <p:spPr>
          <a:xfrm>
            <a:off x="8018280" y="6237360"/>
            <a:ext cx="54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g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テキスト ボックス 17"/>
          <p:cNvSpPr/>
          <p:nvPr/>
        </p:nvSpPr>
        <p:spPr>
          <a:xfrm>
            <a:off x="924840" y="1536840"/>
            <a:ext cx="744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UV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25"/>
          <p:cNvSpPr/>
          <p:nvPr/>
        </p:nvSpPr>
        <p:spPr>
          <a:xfrm>
            <a:off x="1479600" y="4344840"/>
            <a:ext cx="4978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25"/>
          <p:cNvSpPr/>
          <p:nvPr/>
        </p:nvSpPr>
        <p:spPr>
          <a:xfrm>
            <a:off x="1488600" y="3567240"/>
            <a:ext cx="4978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.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5"/>
          <p:cNvSpPr/>
          <p:nvPr/>
        </p:nvSpPr>
        <p:spPr>
          <a:xfrm>
            <a:off x="1497240" y="2787480"/>
            <a:ext cx="4978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25"/>
          <p:cNvSpPr/>
          <p:nvPr/>
        </p:nvSpPr>
        <p:spPr>
          <a:xfrm>
            <a:off x="1523520" y="2008080"/>
            <a:ext cx="4978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.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25"/>
          <p:cNvSpPr/>
          <p:nvPr/>
        </p:nvSpPr>
        <p:spPr>
          <a:xfrm>
            <a:off x="1532160" y="1228680"/>
            <a:ext cx="4978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.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25"/>
          <p:cNvSpPr/>
          <p:nvPr/>
        </p:nvSpPr>
        <p:spPr>
          <a:xfrm>
            <a:off x="1505880" y="5124600"/>
            <a:ext cx="4978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0.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25"/>
          <p:cNvSpPr/>
          <p:nvPr/>
        </p:nvSpPr>
        <p:spPr>
          <a:xfrm>
            <a:off x="1514520" y="5904000"/>
            <a:ext cx="4978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0" name="グループ化 34"/>
          <p:cNvGrpSpPr/>
          <p:nvPr/>
        </p:nvGrpSpPr>
        <p:grpSpPr>
          <a:xfrm>
            <a:off x="3123720" y="2625480"/>
            <a:ext cx="1016640" cy="161640"/>
            <a:chOff x="3123720" y="2625480"/>
            <a:chExt cx="1016640" cy="161640"/>
          </a:xfrm>
        </p:grpSpPr>
        <p:sp>
          <p:nvSpPr>
            <p:cNvPr id="71" name="直線コネクタ 31"/>
            <p:cNvSpPr/>
            <p:nvPr/>
          </p:nvSpPr>
          <p:spPr>
            <a:xfrm flipV="1">
              <a:off x="3124080" y="2625480"/>
              <a:ext cx="0" cy="161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直線コネクタ 32"/>
            <p:cNvSpPr/>
            <p:nvPr/>
          </p:nvSpPr>
          <p:spPr>
            <a:xfrm flipV="1">
              <a:off x="4140360" y="2625480"/>
              <a:ext cx="0" cy="161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直線コネクタ 33"/>
            <p:cNvSpPr/>
            <p:nvPr/>
          </p:nvSpPr>
          <p:spPr>
            <a:xfrm flipH="1">
              <a:off x="3123720" y="2625840"/>
              <a:ext cx="1016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4" name="グループ化 34"/>
          <p:cNvGrpSpPr/>
          <p:nvPr/>
        </p:nvGrpSpPr>
        <p:grpSpPr>
          <a:xfrm>
            <a:off x="4184640" y="2422440"/>
            <a:ext cx="1015920" cy="162000"/>
            <a:chOff x="4184640" y="2422440"/>
            <a:chExt cx="1015920" cy="162000"/>
          </a:xfrm>
        </p:grpSpPr>
        <p:sp>
          <p:nvSpPr>
            <p:cNvPr id="75" name="直線コネクタ 35"/>
            <p:cNvSpPr/>
            <p:nvPr/>
          </p:nvSpPr>
          <p:spPr>
            <a:xfrm flipV="1">
              <a:off x="4184640" y="2422440"/>
              <a:ext cx="0" cy="1620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直線コネクタ 36"/>
            <p:cNvSpPr/>
            <p:nvPr/>
          </p:nvSpPr>
          <p:spPr>
            <a:xfrm flipV="1">
              <a:off x="5200560" y="2422440"/>
              <a:ext cx="0" cy="1620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直線コネクタ 37"/>
            <p:cNvSpPr/>
            <p:nvPr/>
          </p:nvSpPr>
          <p:spPr>
            <a:xfrm flipH="1">
              <a:off x="4184640" y="2422440"/>
              <a:ext cx="10159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8" name="グループ化 38"/>
          <p:cNvGrpSpPr/>
          <p:nvPr/>
        </p:nvGrpSpPr>
        <p:grpSpPr>
          <a:xfrm>
            <a:off x="5207040" y="2225160"/>
            <a:ext cx="1015920" cy="163800"/>
            <a:chOff x="5207040" y="2225160"/>
            <a:chExt cx="1015920" cy="163800"/>
          </a:xfrm>
        </p:grpSpPr>
        <p:sp>
          <p:nvSpPr>
            <p:cNvPr id="79" name="直線コネクタ 39"/>
            <p:cNvSpPr/>
            <p:nvPr/>
          </p:nvSpPr>
          <p:spPr>
            <a:xfrm flipV="1">
              <a:off x="5207040" y="2225160"/>
              <a:ext cx="0" cy="163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直線コネクタ 40"/>
            <p:cNvSpPr/>
            <p:nvPr/>
          </p:nvSpPr>
          <p:spPr>
            <a:xfrm flipV="1">
              <a:off x="6222960" y="2225160"/>
              <a:ext cx="0" cy="163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直線コネクタ 41"/>
            <p:cNvSpPr/>
            <p:nvPr/>
          </p:nvSpPr>
          <p:spPr>
            <a:xfrm flipH="1">
              <a:off x="5207040" y="2225520"/>
              <a:ext cx="10159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2" name="グループ化 42"/>
          <p:cNvGrpSpPr/>
          <p:nvPr/>
        </p:nvGrpSpPr>
        <p:grpSpPr>
          <a:xfrm>
            <a:off x="6262200" y="1994040"/>
            <a:ext cx="1016640" cy="163440"/>
            <a:chOff x="6262200" y="1994040"/>
            <a:chExt cx="1016640" cy="163440"/>
          </a:xfrm>
        </p:grpSpPr>
        <p:sp>
          <p:nvSpPr>
            <p:cNvPr id="83" name="直線コネクタ 43"/>
            <p:cNvSpPr/>
            <p:nvPr/>
          </p:nvSpPr>
          <p:spPr>
            <a:xfrm flipV="1">
              <a:off x="6262560" y="1994040"/>
              <a:ext cx="0" cy="163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直線コネクタ 44"/>
            <p:cNvSpPr/>
            <p:nvPr/>
          </p:nvSpPr>
          <p:spPr>
            <a:xfrm flipV="1">
              <a:off x="7278840" y="1994040"/>
              <a:ext cx="0" cy="163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直線コネクタ 45"/>
            <p:cNvSpPr/>
            <p:nvPr/>
          </p:nvSpPr>
          <p:spPr>
            <a:xfrm flipH="1">
              <a:off x="6262200" y="1994040"/>
              <a:ext cx="10162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6" name="テキスト ボックス 33"/>
          <p:cNvSpPr/>
          <p:nvPr/>
        </p:nvSpPr>
        <p:spPr>
          <a:xfrm>
            <a:off x="6491160" y="1725480"/>
            <a:ext cx="557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テキスト ボックス 33"/>
          <p:cNvSpPr/>
          <p:nvPr/>
        </p:nvSpPr>
        <p:spPr>
          <a:xfrm>
            <a:off x="5508720" y="1938240"/>
            <a:ext cx="557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テキスト ボックス 33"/>
          <p:cNvSpPr/>
          <p:nvPr/>
        </p:nvSpPr>
        <p:spPr>
          <a:xfrm>
            <a:off x="4444920" y="2154240"/>
            <a:ext cx="55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テキスト ボックス 33"/>
          <p:cNvSpPr/>
          <p:nvPr/>
        </p:nvSpPr>
        <p:spPr>
          <a:xfrm>
            <a:off x="3365640" y="2370240"/>
            <a:ext cx="55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0" name="グループ化 34"/>
          <p:cNvGrpSpPr/>
          <p:nvPr/>
        </p:nvGrpSpPr>
        <p:grpSpPr>
          <a:xfrm>
            <a:off x="4140000" y="1373040"/>
            <a:ext cx="3106800" cy="139680"/>
            <a:chOff x="4140000" y="1373040"/>
            <a:chExt cx="3106800" cy="139680"/>
          </a:xfrm>
        </p:grpSpPr>
        <p:sp>
          <p:nvSpPr>
            <p:cNvPr id="91" name="直線コネクタ 51"/>
            <p:cNvSpPr/>
            <p:nvPr/>
          </p:nvSpPr>
          <p:spPr>
            <a:xfrm flipV="1">
              <a:off x="4140360" y="1373040"/>
              <a:ext cx="0" cy="1396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直線コネクタ 52"/>
            <p:cNvSpPr/>
            <p:nvPr/>
          </p:nvSpPr>
          <p:spPr>
            <a:xfrm flipV="1">
              <a:off x="7246800" y="1373040"/>
              <a:ext cx="0" cy="1396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直線コネクタ 53"/>
            <p:cNvSpPr/>
            <p:nvPr/>
          </p:nvSpPr>
          <p:spPr>
            <a:xfrm flipH="1">
              <a:off x="4140000" y="1373040"/>
              <a:ext cx="31064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4" name="グループ化 54"/>
          <p:cNvGrpSpPr/>
          <p:nvPr/>
        </p:nvGrpSpPr>
        <p:grpSpPr>
          <a:xfrm>
            <a:off x="5207040" y="1589040"/>
            <a:ext cx="2039760" cy="184320"/>
            <a:chOff x="5207040" y="1589040"/>
            <a:chExt cx="2039760" cy="184320"/>
          </a:xfrm>
        </p:grpSpPr>
        <p:sp>
          <p:nvSpPr>
            <p:cNvPr id="95" name="直線コネクタ 55"/>
            <p:cNvSpPr/>
            <p:nvPr/>
          </p:nvSpPr>
          <p:spPr>
            <a:xfrm flipV="1">
              <a:off x="5207040" y="1589040"/>
              <a:ext cx="0" cy="184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直線コネクタ 56"/>
            <p:cNvSpPr/>
            <p:nvPr/>
          </p:nvSpPr>
          <p:spPr>
            <a:xfrm flipV="1">
              <a:off x="7246800" y="1589040"/>
              <a:ext cx="0" cy="1843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直線コネクタ 57"/>
            <p:cNvSpPr/>
            <p:nvPr/>
          </p:nvSpPr>
          <p:spPr>
            <a:xfrm flipH="1">
              <a:off x="5207040" y="1589040"/>
              <a:ext cx="2039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8" name="テキスト ボックス 33"/>
          <p:cNvSpPr/>
          <p:nvPr/>
        </p:nvSpPr>
        <p:spPr>
          <a:xfrm>
            <a:off x="5651640" y="1074600"/>
            <a:ext cx="55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テキスト ボックス 33"/>
          <p:cNvSpPr/>
          <p:nvPr/>
        </p:nvSpPr>
        <p:spPr>
          <a:xfrm>
            <a:off x="6173640" y="1268280"/>
            <a:ext cx="559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0" name="グループ化 34"/>
          <p:cNvGrpSpPr/>
          <p:nvPr/>
        </p:nvGrpSpPr>
        <p:grpSpPr>
          <a:xfrm>
            <a:off x="3132000" y="1849320"/>
            <a:ext cx="3106800" cy="139680"/>
            <a:chOff x="3132000" y="1849320"/>
            <a:chExt cx="3106800" cy="139680"/>
          </a:xfrm>
        </p:grpSpPr>
        <p:sp>
          <p:nvSpPr>
            <p:cNvPr id="101" name="直線コネクタ 61"/>
            <p:cNvSpPr/>
            <p:nvPr/>
          </p:nvSpPr>
          <p:spPr>
            <a:xfrm flipV="1">
              <a:off x="3132000" y="1849320"/>
              <a:ext cx="0" cy="1396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直線コネクタ 62"/>
            <p:cNvSpPr/>
            <p:nvPr/>
          </p:nvSpPr>
          <p:spPr>
            <a:xfrm flipV="1">
              <a:off x="6238800" y="1849320"/>
              <a:ext cx="0" cy="13968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直線コネクタ 63"/>
            <p:cNvSpPr/>
            <p:nvPr/>
          </p:nvSpPr>
          <p:spPr>
            <a:xfrm flipH="1">
              <a:off x="3132000" y="1849320"/>
              <a:ext cx="31068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4" name="グループ化 64"/>
          <p:cNvGrpSpPr/>
          <p:nvPr/>
        </p:nvGrpSpPr>
        <p:grpSpPr>
          <a:xfrm>
            <a:off x="4187880" y="2020680"/>
            <a:ext cx="2039760" cy="183960"/>
            <a:chOff x="4187880" y="2020680"/>
            <a:chExt cx="2039760" cy="183960"/>
          </a:xfrm>
        </p:grpSpPr>
        <p:sp>
          <p:nvSpPr>
            <p:cNvPr id="105" name="直線コネクタ 65"/>
            <p:cNvSpPr/>
            <p:nvPr/>
          </p:nvSpPr>
          <p:spPr>
            <a:xfrm flipV="1">
              <a:off x="4187880" y="2020680"/>
              <a:ext cx="0" cy="183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直線コネクタ 66"/>
            <p:cNvSpPr/>
            <p:nvPr/>
          </p:nvSpPr>
          <p:spPr>
            <a:xfrm flipV="1">
              <a:off x="6227640" y="2020680"/>
              <a:ext cx="0" cy="1839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直線コネクタ 67"/>
            <p:cNvSpPr/>
            <p:nvPr/>
          </p:nvSpPr>
          <p:spPr>
            <a:xfrm flipH="1">
              <a:off x="4187880" y="2021040"/>
              <a:ext cx="20397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8" name="テキスト ボックス 33"/>
          <p:cNvSpPr/>
          <p:nvPr/>
        </p:nvSpPr>
        <p:spPr>
          <a:xfrm>
            <a:off x="4373640" y="1577880"/>
            <a:ext cx="55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テキスト ボックス 33"/>
          <p:cNvSpPr/>
          <p:nvPr/>
        </p:nvSpPr>
        <p:spPr>
          <a:xfrm>
            <a:off x="4932360" y="1773360"/>
            <a:ext cx="55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0" name="グループ化 74"/>
          <p:cNvGrpSpPr/>
          <p:nvPr/>
        </p:nvGrpSpPr>
        <p:grpSpPr>
          <a:xfrm>
            <a:off x="3131640" y="2204640"/>
            <a:ext cx="2040480" cy="182520"/>
            <a:chOff x="3131640" y="2204640"/>
            <a:chExt cx="2040480" cy="182520"/>
          </a:xfrm>
        </p:grpSpPr>
        <p:sp>
          <p:nvSpPr>
            <p:cNvPr id="111" name="直線コネクタ 75"/>
            <p:cNvSpPr/>
            <p:nvPr/>
          </p:nvSpPr>
          <p:spPr>
            <a:xfrm flipV="1">
              <a:off x="3132000" y="2204640"/>
              <a:ext cx="0" cy="1825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直線コネクタ 76"/>
            <p:cNvSpPr/>
            <p:nvPr/>
          </p:nvSpPr>
          <p:spPr>
            <a:xfrm flipV="1">
              <a:off x="5172120" y="2204640"/>
              <a:ext cx="0" cy="1825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直線コネクタ 77"/>
            <p:cNvSpPr/>
            <p:nvPr/>
          </p:nvSpPr>
          <p:spPr>
            <a:xfrm flipH="1">
              <a:off x="3131640" y="2205000"/>
              <a:ext cx="20401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4" name="テキスト ボックス 33"/>
          <p:cNvSpPr/>
          <p:nvPr/>
        </p:nvSpPr>
        <p:spPr>
          <a:xfrm>
            <a:off x="3652920" y="1925640"/>
            <a:ext cx="558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20"/>
          <p:cNvSpPr/>
          <p:nvPr/>
        </p:nvSpPr>
        <p:spPr>
          <a:xfrm>
            <a:off x="54000" y="138240"/>
            <a:ext cx="2214360" cy="48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 fontScale="79000"/>
          </a:bodyPr>
          <a:p>
            <a:pPr>
              <a:lnSpc>
                <a:spcPct val="100000"/>
              </a:lnSpc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メイリオ"/>
                <a:ea typeface="メイリオ"/>
              </a:rPr>
              <a:t>Sup. Fig.1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Rectangle 20"/>
          <p:cNvSpPr/>
          <p:nvPr/>
        </p:nvSpPr>
        <p:spPr>
          <a:xfrm>
            <a:off x="54000" y="138240"/>
            <a:ext cx="2214360" cy="48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 fontScale="79000"/>
          </a:bodyPr>
          <a:p>
            <a:pPr>
              <a:lnSpc>
                <a:spcPct val="100000"/>
              </a:lnSpc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メイリオ"/>
                <a:ea typeface="メイリオ"/>
              </a:rPr>
              <a:t>Sup. Fig.2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7" name="図 1" descr=""/>
          <p:cNvPicPr/>
          <p:nvPr/>
        </p:nvPicPr>
        <p:blipFill>
          <a:blip r:embed="rId1"/>
          <a:stretch/>
        </p:blipFill>
        <p:spPr>
          <a:xfrm>
            <a:off x="971640" y="636480"/>
            <a:ext cx="7824600" cy="5888160"/>
          </a:xfrm>
          <a:prstGeom prst="rect">
            <a:avLst/>
          </a:prstGeom>
          <a:ln w="0">
            <a:noFill/>
          </a:ln>
        </p:spPr>
      </p:pic>
      <p:sp>
        <p:nvSpPr>
          <p:cNvPr id="118" name="テキスト ボックス 1"/>
          <p:cNvSpPr/>
          <p:nvPr/>
        </p:nvSpPr>
        <p:spPr>
          <a:xfrm>
            <a:off x="2159280" y="620640"/>
            <a:ext cx="5833080" cy="368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egional SUVR of healthy volunteers in each age rang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9" name="FPYBF2_HIGASHI^TATSUYA.20131111.avi" descr=""/>
          <p:cNvPicPr/>
          <p:nvPr/>
        </p:nvPicPr>
        <p:blipFill>
          <a:blip r:embed="rId1"/>
          <a:stretch/>
        </p:blipFill>
        <p:spPr>
          <a:xfrm>
            <a:off x="3048120" y="600120"/>
            <a:ext cx="3314520" cy="5937120"/>
          </a:xfrm>
          <a:prstGeom prst="rect">
            <a:avLst/>
          </a:prstGeom>
          <a:ln w="0">
            <a:noFill/>
          </a:ln>
        </p:spPr>
      </p:pic>
      <p:pic>
        <p:nvPicPr>
          <p:cNvPr id="120" name="図 11" descr="20140214HH_50suvr_73yoMale.jpg"/>
          <p:cNvPicPr/>
          <p:nvPr/>
        </p:nvPicPr>
        <p:blipFill>
          <a:blip r:embed="rId2"/>
          <a:srcRect l="69140" t="3439" r="28445" b="5135"/>
          <a:stretch/>
        </p:blipFill>
        <p:spPr>
          <a:xfrm>
            <a:off x="6362640" y="549360"/>
            <a:ext cx="225360" cy="6022800"/>
          </a:xfrm>
          <a:prstGeom prst="rect">
            <a:avLst/>
          </a:prstGeom>
          <a:ln w="0">
            <a:noFill/>
          </a:ln>
        </p:spPr>
      </p:pic>
      <p:sp>
        <p:nvSpPr>
          <p:cNvPr id="121" name="Rectangle 20"/>
          <p:cNvSpPr/>
          <p:nvPr/>
        </p:nvSpPr>
        <p:spPr>
          <a:xfrm>
            <a:off x="6588000" y="3375000"/>
            <a:ext cx="108288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74000"/>
          </a:bodyPr>
          <a:p>
            <a:pPr>
              <a:lnSpc>
                <a:spcPct val="12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メイリオ"/>
                <a:ea typeface="メイリオ"/>
              </a:rPr>
              <a:t>SUVR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20"/>
          <p:cNvSpPr/>
          <p:nvPr/>
        </p:nvSpPr>
        <p:spPr>
          <a:xfrm>
            <a:off x="6588000" y="6168960"/>
            <a:ext cx="43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75000"/>
          </a:bodyPr>
          <a:p>
            <a:pPr>
              <a:lnSpc>
                <a:spcPct val="12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メイリオ"/>
                <a:ea typeface="メイリオ"/>
              </a:rPr>
              <a:t>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20"/>
          <p:cNvSpPr/>
          <p:nvPr/>
        </p:nvSpPr>
        <p:spPr>
          <a:xfrm>
            <a:off x="6588000" y="620640"/>
            <a:ext cx="720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75000"/>
          </a:bodyPr>
          <a:p>
            <a:pPr>
              <a:lnSpc>
                <a:spcPct val="12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メイリオ"/>
                <a:ea typeface="メイリオ"/>
              </a:rPr>
              <a:t>3.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20"/>
          <p:cNvSpPr/>
          <p:nvPr/>
        </p:nvSpPr>
        <p:spPr>
          <a:xfrm>
            <a:off x="54000" y="138240"/>
            <a:ext cx="2214360" cy="48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 fontScale="79000"/>
          </a:bodyPr>
          <a:p>
            <a:pPr>
              <a:lnSpc>
                <a:spcPct val="100000"/>
              </a:lnSpc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メイリオ"/>
                <a:ea typeface="メイリオ"/>
              </a:rPr>
              <a:t>Sup. Fig.3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nodeType="clickEffect" fill="hold">
                      <p:stCondLst>
                        <p:cond delay="0"/>
                      </p:stCondLst>
                      <p:childTnLst>
                        <p:par>
                          <p:cTn id="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afterEffect" fill="hold" presetClass="mediacall" presetID="1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400" fill="hold"/>
                                        <p:tgtEl>
                                          <p:spTgt spid="11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  <p:seq>
              <p:cTn id="7" restart="whenNotActive" nodeType="interactiveSeq" fill="hold">
                <p:stCondLst>
                  <p:cond evt="onClick">
                    <p:tgtEl>
                      <p:spTgt spid="119"/>
                    </p:tgtEl>
                  </p:cond>
                </p:stCondLst>
                <p:childTnLst>
                  <p:par>
                    <p:cTn id="8" nodeType="clickEffect" fill="hold">
                      <p:stCondLst>
                        <p:cond evt="onClick">
                          <p:tgtEl>
                            <p:spTgt spid="119"/>
                          </p:tgtEl>
                        </p:cond>
                      </p:stCondLst>
                      <p:childTnLst>
                        <p:par>
                          <p:cTn id="9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10" nodeType="clickEffect" fill="hold" presetClass="mediacall" presetID="2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11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Rectangle 20"/>
          <p:cNvSpPr/>
          <p:nvPr/>
        </p:nvSpPr>
        <p:spPr>
          <a:xfrm>
            <a:off x="54000" y="138240"/>
            <a:ext cx="2502000" cy="48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 fontScale="79000"/>
          </a:bodyPr>
          <a:p>
            <a:pPr>
              <a:lnSpc>
                <a:spcPct val="100000"/>
              </a:lnSpc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メイリオ"/>
                <a:ea typeface="メイリオ"/>
              </a:rPr>
              <a:t>Sup. Fig. 4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6" name="グラフ 3" descr=""/>
          <p:cNvPicPr/>
          <p:nvPr/>
        </p:nvPicPr>
        <p:blipFill>
          <a:blip r:embed="rId1"/>
          <a:stretch/>
        </p:blipFill>
        <p:spPr>
          <a:xfrm>
            <a:off x="390600" y="1468440"/>
            <a:ext cx="8448480" cy="5127480"/>
          </a:xfrm>
          <a:prstGeom prst="rect">
            <a:avLst/>
          </a:prstGeom>
          <a:ln w="0">
            <a:noFill/>
          </a:ln>
        </p:spPr>
      </p:pic>
      <p:sp>
        <p:nvSpPr>
          <p:cNvPr id="127" name="タイトル 1"/>
          <p:cNvSpPr/>
          <p:nvPr/>
        </p:nvSpPr>
        <p:spPr>
          <a:xfrm>
            <a:off x="609480" y="620640"/>
            <a:ext cx="8229600" cy="49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3000"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5 hours Prolonged study in a volunteer (n=1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タイトル 1"/>
          <p:cNvSpPr/>
          <p:nvPr/>
        </p:nvSpPr>
        <p:spPr>
          <a:xfrm>
            <a:off x="6516720" y="6237360"/>
            <a:ext cx="143028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97000"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2a2a2a"/>
                </a:solidFill>
                <a:latin typeface="Arial"/>
              </a:rPr>
              <a:t>Time (hour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15"/>
          <p:cNvSpPr/>
          <p:nvPr/>
        </p:nvSpPr>
        <p:spPr>
          <a:xfrm>
            <a:off x="257400" y="1108080"/>
            <a:ext cx="703440" cy="398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SUV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テキスト ボックス 9"/>
          <p:cNvSpPr/>
          <p:nvPr/>
        </p:nvSpPr>
        <p:spPr>
          <a:xfrm>
            <a:off x="6749280" y="2349360"/>
            <a:ext cx="2209320" cy="2837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Po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erebellu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halamu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ortex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ean Cortical Index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1" name="グラフ 56" descr=""/>
          <p:cNvPicPr/>
          <p:nvPr/>
        </p:nvPicPr>
        <p:blipFill>
          <a:blip r:embed="rId1"/>
          <a:stretch/>
        </p:blipFill>
        <p:spPr>
          <a:xfrm>
            <a:off x="4065480" y="3859200"/>
            <a:ext cx="3853080" cy="2882880"/>
          </a:xfrm>
          <a:prstGeom prst="rect">
            <a:avLst/>
          </a:prstGeom>
          <a:ln w="0">
            <a:noFill/>
          </a:ln>
        </p:spPr>
      </p:pic>
      <p:pic>
        <p:nvPicPr>
          <p:cNvPr id="132" name="グラフ 55" descr=""/>
          <p:cNvPicPr/>
          <p:nvPr/>
        </p:nvPicPr>
        <p:blipFill>
          <a:blip r:embed="rId2"/>
          <a:stretch/>
        </p:blipFill>
        <p:spPr>
          <a:xfrm>
            <a:off x="176040" y="3859200"/>
            <a:ext cx="3853080" cy="2882880"/>
          </a:xfrm>
          <a:prstGeom prst="rect">
            <a:avLst/>
          </a:prstGeom>
          <a:ln w="0">
            <a:noFill/>
          </a:ln>
        </p:spPr>
      </p:pic>
      <p:pic>
        <p:nvPicPr>
          <p:cNvPr id="133" name="グラフ 51" descr=""/>
          <p:cNvPicPr/>
          <p:nvPr/>
        </p:nvPicPr>
        <p:blipFill>
          <a:blip r:embed="rId3"/>
          <a:stretch/>
        </p:blipFill>
        <p:spPr>
          <a:xfrm>
            <a:off x="176040" y="974880"/>
            <a:ext cx="3853080" cy="2786040"/>
          </a:xfrm>
          <a:prstGeom prst="rect">
            <a:avLst/>
          </a:prstGeom>
          <a:ln w="0">
            <a:noFill/>
          </a:ln>
        </p:spPr>
      </p:pic>
      <p:pic>
        <p:nvPicPr>
          <p:cNvPr id="134" name="グラフ 53" descr=""/>
          <p:cNvPicPr/>
          <p:nvPr/>
        </p:nvPicPr>
        <p:blipFill>
          <a:blip r:embed="rId4"/>
          <a:stretch/>
        </p:blipFill>
        <p:spPr>
          <a:xfrm>
            <a:off x="4065480" y="974880"/>
            <a:ext cx="3853080" cy="2786040"/>
          </a:xfrm>
          <a:prstGeom prst="rect">
            <a:avLst/>
          </a:prstGeom>
          <a:ln w="0">
            <a:noFill/>
          </a:ln>
        </p:spPr>
      </p:pic>
      <p:sp>
        <p:nvSpPr>
          <p:cNvPr id="135" name="テキスト ボックス 3"/>
          <p:cNvSpPr/>
          <p:nvPr/>
        </p:nvSpPr>
        <p:spPr>
          <a:xfrm>
            <a:off x="2001240" y="1486080"/>
            <a:ext cx="155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rontal  lob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テキスト ボックス 5"/>
          <p:cNvSpPr/>
          <p:nvPr/>
        </p:nvSpPr>
        <p:spPr>
          <a:xfrm>
            <a:off x="5839200" y="1413000"/>
            <a:ext cx="1604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arietal  lob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正方形/長方形 10"/>
          <p:cNvSpPr/>
          <p:nvPr/>
        </p:nvSpPr>
        <p:spPr>
          <a:xfrm>
            <a:off x="36360" y="3500280"/>
            <a:ext cx="842508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正方形/長方形 11"/>
          <p:cNvSpPr/>
          <p:nvPr/>
        </p:nvSpPr>
        <p:spPr>
          <a:xfrm>
            <a:off x="108000" y="6524640"/>
            <a:ext cx="8424720" cy="217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テキスト ボックス 20"/>
          <p:cNvSpPr/>
          <p:nvPr/>
        </p:nvSpPr>
        <p:spPr>
          <a:xfrm>
            <a:off x="1771560" y="4303800"/>
            <a:ext cx="174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Occipital  lob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テキスト ボックス 21"/>
          <p:cNvSpPr/>
          <p:nvPr/>
        </p:nvSpPr>
        <p:spPr>
          <a:xfrm>
            <a:off x="5580720" y="4292640"/>
            <a:ext cx="1808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emporal  lob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1" name="グループ化 22"/>
          <p:cNvGrpSpPr/>
          <p:nvPr/>
        </p:nvGrpSpPr>
        <p:grpSpPr>
          <a:xfrm>
            <a:off x="1258920" y="1339920"/>
            <a:ext cx="2232000" cy="217440"/>
            <a:chOff x="1258920" y="1339920"/>
            <a:chExt cx="2232000" cy="217440"/>
          </a:xfrm>
        </p:grpSpPr>
        <p:sp>
          <p:nvSpPr>
            <p:cNvPr id="142" name="直線コネクタ 23"/>
            <p:cNvSpPr/>
            <p:nvPr/>
          </p:nvSpPr>
          <p:spPr>
            <a:xfrm flipV="1">
              <a:off x="1258920" y="1339920"/>
              <a:ext cx="0" cy="217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直線コネクタ 24"/>
            <p:cNvSpPr/>
            <p:nvPr/>
          </p:nvSpPr>
          <p:spPr>
            <a:xfrm flipV="1">
              <a:off x="3490920" y="1339920"/>
              <a:ext cx="0" cy="217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直線コネクタ 25"/>
            <p:cNvSpPr/>
            <p:nvPr/>
          </p:nvSpPr>
          <p:spPr>
            <a:xfrm flipH="1">
              <a:off x="1258920" y="1339920"/>
              <a:ext cx="2232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5" name="テキスト ボックス 26"/>
          <p:cNvSpPr/>
          <p:nvPr/>
        </p:nvSpPr>
        <p:spPr>
          <a:xfrm>
            <a:off x="1687320" y="981000"/>
            <a:ext cx="976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 &lt;0.00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6" name="グループ化 27"/>
          <p:cNvGrpSpPr/>
          <p:nvPr/>
        </p:nvGrpSpPr>
        <p:grpSpPr>
          <a:xfrm>
            <a:off x="5219640" y="1196640"/>
            <a:ext cx="2160720" cy="144360"/>
            <a:chOff x="5219640" y="1196640"/>
            <a:chExt cx="2160720" cy="144360"/>
          </a:xfrm>
        </p:grpSpPr>
        <p:sp>
          <p:nvSpPr>
            <p:cNvPr id="147" name="直線コネクタ 28"/>
            <p:cNvSpPr/>
            <p:nvPr/>
          </p:nvSpPr>
          <p:spPr>
            <a:xfrm flipV="1">
              <a:off x="5219640" y="1196640"/>
              <a:ext cx="0" cy="144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直線コネクタ 29"/>
            <p:cNvSpPr/>
            <p:nvPr/>
          </p:nvSpPr>
          <p:spPr>
            <a:xfrm flipV="1">
              <a:off x="7380360" y="1196640"/>
              <a:ext cx="0" cy="144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直線コネクタ 30"/>
            <p:cNvSpPr/>
            <p:nvPr/>
          </p:nvSpPr>
          <p:spPr>
            <a:xfrm flipH="1">
              <a:off x="5219640" y="1197000"/>
              <a:ext cx="2160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0" name="テキスト ボックス 31"/>
          <p:cNvSpPr/>
          <p:nvPr/>
        </p:nvSpPr>
        <p:spPr>
          <a:xfrm>
            <a:off x="5676840" y="858960"/>
            <a:ext cx="976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 &lt;0.00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テキスト ボックス 32"/>
          <p:cNvSpPr/>
          <p:nvPr/>
        </p:nvSpPr>
        <p:spPr>
          <a:xfrm>
            <a:off x="1771560" y="3789360"/>
            <a:ext cx="976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 &lt;0.00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テキスト ボックス 33"/>
          <p:cNvSpPr/>
          <p:nvPr/>
        </p:nvSpPr>
        <p:spPr>
          <a:xfrm>
            <a:off x="5657760" y="3789360"/>
            <a:ext cx="976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 &lt;0.00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3" name="グループ化 34"/>
          <p:cNvGrpSpPr/>
          <p:nvPr/>
        </p:nvGrpSpPr>
        <p:grpSpPr>
          <a:xfrm>
            <a:off x="1186920" y="4149360"/>
            <a:ext cx="2305440" cy="142920"/>
            <a:chOff x="1186920" y="4149360"/>
            <a:chExt cx="2305440" cy="142920"/>
          </a:xfrm>
        </p:grpSpPr>
        <p:sp>
          <p:nvSpPr>
            <p:cNvPr id="154" name="直線コネクタ 35"/>
            <p:cNvSpPr/>
            <p:nvPr/>
          </p:nvSpPr>
          <p:spPr>
            <a:xfrm flipV="1">
              <a:off x="1187280" y="4149360"/>
              <a:ext cx="0" cy="142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直線コネクタ 36"/>
            <p:cNvSpPr/>
            <p:nvPr/>
          </p:nvSpPr>
          <p:spPr>
            <a:xfrm flipV="1">
              <a:off x="3492360" y="4149360"/>
              <a:ext cx="0" cy="1429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直線コネクタ 37"/>
            <p:cNvSpPr/>
            <p:nvPr/>
          </p:nvSpPr>
          <p:spPr>
            <a:xfrm flipH="1">
              <a:off x="1186920" y="4149720"/>
              <a:ext cx="23050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57" name="グループ化 38"/>
          <p:cNvGrpSpPr/>
          <p:nvPr/>
        </p:nvGrpSpPr>
        <p:grpSpPr>
          <a:xfrm>
            <a:off x="5076720" y="4127400"/>
            <a:ext cx="2232000" cy="93600"/>
            <a:chOff x="5076720" y="4127400"/>
            <a:chExt cx="2232000" cy="93600"/>
          </a:xfrm>
        </p:grpSpPr>
        <p:sp>
          <p:nvSpPr>
            <p:cNvPr id="158" name="直線コネクタ 39"/>
            <p:cNvSpPr/>
            <p:nvPr/>
          </p:nvSpPr>
          <p:spPr>
            <a:xfrm flipV="1">
              <a:off x="5076720" y="4127400"/>
              <a:ext cx="0" cy="93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直線コネクタ 40"/>
            <p:cNvSpPr/>
            <p:nvPr/>
          </p:nvSpPr>
          <p:spPr>
            <a:xfrm flipV="1">
              <a:off x="7308720" y="4127400"/>
              <a:ext cx="0" cy="93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直線コネクタ 41"/>
            <p:cNvSpPr/>
            <p:nvPr/>
          </p:nvSpPr>
          <p:spPr>
            <a:xfrm flipH="1">
              <a:off x="5076720" y="4127400"/>
              <a:ext cx="2232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1" name="テキスト ボックス 57"/>
          <p:cNvSpPr/>
          <p:nvPr/>
        </p:nvSpPr>
        <p:spPr>
          <a:xfrm>
            <a:off x="907560" y="6402240"/>
            <a:ext cx="2751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       B      C      D      E      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テキスト ボックス 58"/>
          <p:cNvSpPr/>
          <p:nvPr/>
        </p:nvSpPr>
        <p:spPr>
          <a:xfrm>
            <a:off x="4836600" y="6402240"/>
            <a:ext cx="2751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       B      C      D      E      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テキスト ボックス 59"/>
          <p:cNvSpPr/>
          <p:nvPr/>
        </p:nvSpPr>
        <p:spPr>
          <a:xfrm>
            <a:off x="939240" y="3451320"/>
            <a:ext cx="2751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       B      C      D      E      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テキスト ボックス 60"/>
          <p:cNvSpPr/>
          <p:nvPr/>
        </p:nvSpPr>
        <p:spPr>
          <a:xfrm>
            <a:off x="4867560" y="3451320"/>
            <a:ext cx="2751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       B      C      D      E      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タイトル 1"/>
          <p:cNvSpPr/>
          <p:nvPr/>
        </p:nvSpPr>
        <p:spPr>
          <a:xfrm>
            <a:off x="1681200" y="322200"/>
            <a:ext cx="7093080" cy="473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ＭＳ Ｐゴシック"/>
              </a:rPr>
              <a:t>Regional SUVR in Patients with Dementia and othe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テキスト ボックス 37"/>
          <p:cNvSpPr/>
          <p:nvPr/>
        </p:nvSpPr>
        <p:spPr>
          <a:xfrm>
            <a:off x="7920000" y="1052640"/>
            <a:ext cx="1224000" cy="456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: Moderate Stage A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: Early A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: Mild Cognitive Impairm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: Other Dementi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: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ealthy Volunteers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（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0yo or older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）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: Healthy Volunteers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（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9yo or younger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）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タイトル 1"/>
          <p:cNvSpPr/>
          <p:nvPr/>
        </p:nvSpPr>
        <p:spPr>
          <a:xfrm>
            <a:off x="179280" y="728640"/>
            <a:ext cx="936720" cy="43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a2a2a"/>
                </a:solidFill>
                <a:latin typeface="Arial"/>
              </a:rPr>
              <a:t>SUV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Rectangle 20"/>
          <p:cNvSpPr/>
          <p:nvPr/>
        </p:nvSpPr>
        <p:spPr>
          <a:xfrm>
            <a:off x="54000" y="138240"/>
            <a:ext cx="2286000" cy="48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 fontScale="79000"/>
          </a:bodyPr>
          <a:p>
            <a:pPr>
              <a:lnSpc>
                <a:spcPct val="100000"/>
              </a:lnSpc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メイリオ"/>
                <a:ea typeface="メイリオ"/>
              </a:rPr>
              <a:t>Sup. Fig.5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タイトル 1"/>
          <p:cNvSpPr/>
          <p:nvPr/>
        </p:nvSpPr>
        <p:spPr>
          <a:xfrm>
            <a:off x="179280" y="3643200"/>
            <a:ext cx="936720" cy="43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a2a2a"/>
                </a:solidFill>
                <a:latin typeface="Arial"/>
              </a:rPr>
              <a:t>SUV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0" name="グラフ 45" descr=""/>
          <p:cNvPicPr/>
          <p:nvPr/>
        </p:nvPicPr>
        <p:blipFill>
          <a:blip r:embed="rId1"/>
          <a:stretch/>
        </p:blipFill>
        <p:spPr>
          <a:xfrm>
            <a:off x="4065480" y="974880"/>
            <a:ext cx="3853080" cy="2573280"/>
          </a:xfrm>
          <a:prstGeom prst="rect">
            <a:avLst/>
          </a:prstGeom>
          <a:ln w="0">
            <a:noFill/>
          </a:ln>
        </p:spPr>
      </p:pic>
      <p:pic>
        <p:nvPicPr>
          <p:cNvPr id="171" name="グラフ 44" descr=""/>
          <p:cNvPicPr/>
          <p:nvPr/>
        </p:nvPicPr>
        <p:blipFill>
          <a:blip r:embed="rId2"/>
          <a:stretch/>
        </p:blipFill>
        <p:spPr>
          <a:xfrm>
            <a:off x="103320" y="974880"/>
            <a:ext cx="3859200" cy="2712960"/>
          </a:xfrm>
          <a:prstGeom prst="rect">
            <a:avLst/>
          </a:prstGeom>
          <a:ln w="0">
            <a:noFill/>
          </a:ln>
        </p:spPr>
      </p:pic>
      <p:pic>
        <p:nvPicPr>
          <p:cNvPr id="172" name="グラフ 43" descr=""/>
          <p:cNvPicPr/>
          <p:nvPr/>
        </p:nvPicPr>
        <p:blipFill>
          <a:blip r:embed="rId3"/>
          <a:stretch/>
        </p:blipFill>
        <p:spPr>
          <a:xfrm>
            <a:off x="103320" y="3786120"/>
            <a:ext cx="3859200" cy="2955960"/>
          </a:xfrm>
          <a:prstGeom prst="rect">
            <a:avLst/>
          </a:prstGeom>
          <a:ln w="0">
            <a:noFill/>
          </a:ln>
        </p:spPr>
      </p:pic>
      <p:pic>
        <p:nvPicPr>
          <p:cNvPr id="173" name="グラフ 42" descr=""/>
          <p:cNvPicPr/>
          <p:nvPr/>
        </p:nvPicPr>
        <p:blipFill>
          <a:blip r:embed="rId4"/>
          <a:stretch/>
        </p:blipFill>
        <p:spPr>
          <a:xfrm>
            <a:off x="4065480" y="3786120"/>
            <a:ext cx="3853080" cy="2925720"/>
          </a:xfrm>
          <a:prstGeom prst="rect">
            <a:avLst/>
          </a:prstGeom>
          <a:ln w="0">
            <a:noFill/>
          </a:ln>
        </p:spPr>
      </p:pic>
      <p:sp>
        <p:nvSpPr>
          <p:cNvPr id="174" name="正方形/長方形 10"/>
          <p:cNvSpPr/>
          <p:nvPr/>
        </p:nvSpPr>
        <p:spPr>
          <a:xfrm>
            <a:off x="36360" y="3429000"/>
            <a:ext cx="8425080" cy="216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正方形/長方形 11"/>
          <p:cNvSpPr/>
          <p:nvPr/>
        </p:nvSpPr>
        <p:spPr>
          <a:xfrm>
            <a:off x="108000" y="6524640"/>
            <a:ext cx="8424720" cy="217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6" name="グループ化 22"/>
          <p:cNvGrpSpPr/>
          <p:nvPr/>
        </p:nvGrpSpPr>
        <p:grpSpPr>
          <a:xfrm>
            <a:off x="1042920" y="1196640"/>
            <a:ext cx="2376720" cy="144360"/>
            <a:chOff x="1042920" y="1196640"/>
            <a:chExt cx="2376720" cy="144360"/>
          </a:xfrm>
        </p:grpSpPr>
        <p:sp>
          <p:nvSpPr>
            <p:cNvPr id="177" name="直線コネクタ 23"/>
            <p:cNvSpPr/>
            <p:nvPr/>
          </p:nvSpPr>
          <p:spPr>
            <a:xfrm flipV="1">
              <a:off x="1042920" y="1196640"/>
              <a:ext cx="0" cy="144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直線コネクタ 24"/>
            <p:cNvSpPr/>
            <p:nvPr/>
          </p:nvSpPr>
          <p:spPr>
            <a:xfrm flipV="1">
              <a:off x="3419640" y="1196640"/>
              <a:ext cx="0" cy="144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直線コネクタ 25"/>
            <p:cNvSpPr/>
            <p:nvPr/>
          </p:nvSpPr>
          <p:spPr>
            <a:xfrm flipH="1">
              <a:off x="1042920" y="1197000"/>
              <a:ext cx="23767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0" name="テキスト ボックス 26"/>
          <p:cNvSpPr/>
          <p:nvPr/>
        </p:nvSpPr>
        <p:spPr>
          <a:xfrm>
            <a:off x="1687320" y="836640"/>
            <a:ext cx="976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 &lt;0.00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1" name="グループ化 27"/>
          <p:cNvGrpSpPr/>
          <p:nvPr/>
        </p:nvGrpSpPr>
        <p:grpSpPr>
          <a:xfrm>
            <a:off x="5076720" y="1196640"/>
            <a:ext cx="2232000" cy="144360"/>
            <a:chOff x="5076720" y="1196640"/>
            <a:chExt cx="2232000" cy="144360"/>
          </a:xfrm>
        </p:grpSpPr>
        <p:sp>
          <p:nvSpPr>
            <p:cNvPr id="182" name="直線コネクタ 28"/>
            <p:cNvSpPr/>
            <p:nvPr/>
          </p:nvSpPr>
          <p:spPr>
            <a:xfrm flipV="1">
              <a:off x="5076720" y="1196640"/>
              <a:ext cx="0" cy="144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直線コネクタ 29"/>
            <p:cNvSpPr/>
            <p:nvPr/>
          </p:nvSpPr>
          <p:spPr>
            <a:xfrm flipV="1">
              <a:off x="7308720" y="1196640"/>
              <a:ext cx="0" cy="1443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直線コネクタ 30"/>
            <p:cNvSpPr/>
            <p:nvPr/>
          </p:nvSpPr>
          <p:spPr>
            <a:xfrm flipH="1">
              <a:off x="5076720" y="1197000"/>
              <a:ext cx="2232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5" name="テキスト ボックス 31"/>
          <p:cNvSpPr/>
          <p:nvPr/>
        </p:nvSpPr>
        <p:spPr>
          <a:xfrm>
            <a:off x="5648040" y="836640"/>
            <a:ext cx="976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 &lt;0.00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テキスト ボックス 32"/>
          <p:cNvSpPr/>
          <p:nvPr/>
        </p:nvSpPr>
        <p:spPr>
          <a:xfrm>
            <a:off x="1771560" y="3789360"/>
            <a:ext cx="976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 &lt;0.00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テキスト ボックス 33"/>
          <p:cNvSpPr/>
          <p:nvPr/>
        </p:nvSpPr>
        <p:spPr>
          <a:xfrm>
            <a:off x="5730840" y="3789360"/>
            <a:ext cx="863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 &lt;0.0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8" name="グループ化 34"/>
          <p:cNvGrpSpPr/>
          <p:nvPr/>
        </p:nvGrpSpPr>
        <p:grpSpPr>
          <a:xfrm>
            <a:off x="1116000" y="4127400"/>
            <a:ext cx="2232000" cy="93600"/>
            <a:chOff x="1116000" y="4127400"/>
            <a:chExt cx="2232000" cy="93600"/>
          </a:xfrm>
        </p:grpSpPr>
        <p:sp>
          <p:nvSpPr>
            <p:cNvPr id="189" name="直線コネクタ 35"/>
            <p:cNvSpPr/>
            <p:nvPr/>
          </p:nvSpPr>
          <p:spPr>
            <a:xfrm flipV="1">
              <a:off x="1116000" y="4127400"/>
              <a:ext cx="0" cy="93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直線コネクタ 36"/>
            <p:cNvSpPr/>
            <p:nvPr/>
          </p:nvSpPr>
          <p:spPr>
            <a:xfrm flipV="1">
              <a:off x="3348000" y="4127400"/>
              <a:ext cx="0" cy="936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直線コネクタ 37"/>
            <p:cNvSpPr/>
            <p:nvPr/>
          </p:nvSpPr>
          <p:spPr>
            <a:xfrm flipH="1">
              <a:off x="1116000" y="4127400"/>
              <a:ext cx="2232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2" name="グループ化 38"/>
          <p:cNvGrpSpPr/>
          <p:nvPr/>
        </p:nvGrpSpPr>
        <p:grpSpPr>
          <a:xfrm>
            <a:off x="5076720" y="3860640"/>
            <a:ext cx="2232000" cy="144720"/>
            <a:chOff x="5076720" y="3860640"/>
            <a:chExt cx="2232000" cy="144720"/>
          </a:xfrm>
        </p:grpSpPr>
        <p:sp>
          <p:nvSpPr>
            <p:cNvPr id="193" name="直線コネクタ 39"/>
            <p:cNvSpPr/>
            <p:nvPr/>
          </p:nvSpPr>
          <p:spPr>
            <a:xfrm flipV="1">
              <a:off x="5076720" y="3860640"/>
              <a:ext cx="0" cy="144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直線コネクタ 40"/>
            <p:cNvSpPr/>
            <p:nvPr/>
          </p:nvSpPr>
          <p:spPr>
            <a:xfrm flipV="1">
              <a:off x="7308720" y="3860640"/>
              <a:ext cx="0" cy="14472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直線コネクタ 41"/>
            <p:cNvSpPr/>
            <p:nvPr/>
          </p:nvSpPr>
          <p:spPr>
            <a:xfrm flipH="1">
              <a:off x="5076720" y="3860640"/>
              <a:ext cx="2232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6" name="テキスト ボックス 3"/>
          <p:cNvSpPr/>
          <p:nvPr/>
        </p:nvSpPr>
        <p:spPr>
          <a:xfrm>
            <a:off x="2273760" y="1413000"/>
            <a:ext cx="123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ingulu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テキスト ボックス 5"/>
          <p:cNvSpPr/>
          <p:nvPr/>
        </p:nvSpPr>
        <p:spPr>
          <a:xfrm>
            <a:off x="6019200" y="1413000"/>
            <a:ext cx="151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Limbic  lob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テキスト ボックス 20"/>
          <p:cNvSpPr/>
          <p:nvPr/>
        </p:nvSpPr>
        <p:spPr>
          <a:xfrm>
            <a:off x="2156760" y="6021360"/>
            <a:ext cx="124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halamu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テキスト ボックス 21"/>
          <p:cNvSpPr/>
          <p:nvPr/>
        </p:nvSpPr>
        <p:spPr>
          <a:xfrm>
            <a:off x="6133680" y="6021360"/>
            <a:ext cx="142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bcortic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テキスト ボックス 46"/>
          <p:cNvSpPr/>
          <p:nvPr/>
        </p:nvSpPr>
        <p:spPr>
          <a:xfrm>
            <a:off x="907560" y="6402240"/>
            <a:ext cx="2751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       B      C      D      E      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テキスト ボックス 47"/>
          <p:cNvSpPr/>
          <p:nvPr/>
        </p:nvSpPr>
        <p:spPr>
          <a:xfrm>
            <a:off x="4836600" y="6402240"/>
            <a:ext cx="2751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       B      C      D      E      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テキスト ボックス 49"/>
          <p:cNvSpPr/>
          <p:nvPr/>
        </p:nvSpPr>
        <p:spPr>
          <a:xfrm>
            <a:off x="939240" y="3451320"/>
            <a:ext cx="2751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       B      C      D      E      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テキスト ボックス 50"/>
          <p:cNvSpPr/>
          <p:nvPr/>
        </p:nvSpPr>
        <p:spPr>
          <a:xfrm>
            <a:off x="4867560" y="3451320"/>
            <a:ext cx="2751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       B      C      D      E      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テキスト ボックス 37"/>
          <p:cNvSpPr/>
          <p:nvPr/>
        </p:nvSpPr>
        <p:spPr>
          <a:xfrm>
            <a:off x="7920000" y="1052640"/>
            <a:ext cx="1224000" cy="456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: Moderate Stage A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: Early A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: Mild Cognitive Impairm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: Other Dementi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E: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ealthy Volunteers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（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0yo or older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）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: Healthy Volunteers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（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9yo or younger</a:t>
            </a: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）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タイトル 1"/>
          <p:cNvSpPr/>
          <p:nvPr/>
        </p:nvSpPr>
        <p:spPr>
          <a:xfrm>
            <a:off x="1979640" y="322200"/>
            <a:ext cx="6794640" cy="473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ＭＳ Ｐゴシック"/>
              </a:rPr>
              <a:t>Regional SUVR in Patients with Dementia and other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タイトル 1"/>
          <p:cNvSpPr/>
          <p:nvPr/>
        </p:nvSpPr>
        <p:spPr>
          <a:xfrm>
            <a:off x="179280" y="728640"/>
            <a:ext cx="936720" cy="43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a2a2a"/>
                </a:solidFill>
                <a:latin typeface="Arial"/>
              </a:rPr>
              <a:t>SUV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Rectangle 20"/>
          <p:cNvSpPr/>
          <p:nvPr/>
        </p:nvSpPr>
        <p:spPr>
          <a:xfrm>
            <a:off x="54000" y="138240"/>
            <a:ext cx="2212920" cy="482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 fontScale="79000"/>
          </a:bodyPr>
          <a:p>
            <a:pPr>
              <a:lnSpc>
                <a:spcPct val="100000"/>
              </a:lnSpc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メイリオ"/>
                <a:ea typeface="メイリオ"/>
              </a:rPr>
              <a:t>Sup. Fig.6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タイトル 1"/>
          <p:cNvSpPr/>
          <p:nvPr/>
        </p:nvSpPr>
        <p:spPr>
          <a:xfrm>
            <a:off x="179280" y="3573360"/>
            <a:ext cx="936720" cy="43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2a2a2a"/>
                </a:solidFill>
                <a:latin typeface="Arial"/>
              </a:rPr>
              <a:t>SUV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17T04:21:18Z</dcterms:created>
  <dc:creator>Tatsuya Higashi</dc:creator>
  <dc:description/>
  <dc:language>en-US</dc:language>
  <cp:lastModifiedBy>東　達也</cp:lastModifiedBy>
  <dcterms:modified xsi:type="dcterms:W3CDTF">2018-01-21T14:51:24Z</dcterms:modified>
  <cp:revision>197</cp:revision>
  <dc:subject/>
  <dc:title>スライド 1</dc:title>
</cp:coreProperties>
</file>